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1879263" cy="80279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DB198-1848-497B-8D5D-EDAD29DC36F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93640" y="322200"/>
            <a:ext cx="10693440" cy="13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93640" y="1873080"/>
            <a:ext cx="1069344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93640" y="4641120"/>
            <a:ext cx="1069344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1FCA0B-BAA8-4577-B2D1-C8879A382A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93640" y="322200"/>
            <a:ext cx="10693440" cy="13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93640" y="1873080"/>
            <a:ext cx="521820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073200" y="1873080"/>
            <a:ext cx="521820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93640" y="4641120"/>
            <a:ext cx="521820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073200" y="4641120"/>
            <a:ext cx="521820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E1AF9-4995-4DCB-85EB-A6F9468565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93640" y="322200"/>
            <a:ext cx="10693440" cy="13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93640" y="1873080"/>
            <a:ext cx="344304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209120" y="1873080"/>
            <a:ext cx="344304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824960" y="1873080"/>
            <a:ext cx="344304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93640" y="4641120"/>
            <a:ext cx="344304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209120" y="4641120"/>
            <a:ext cx="344304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824960" y="4641120"/>
            <a:ext cx="344304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06003-C316-41B3-BB26-BAD886CCBE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93640" y="322200"/>
            <a:ext cx="10693440" cy="13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93640" y="1873080"/>
            <a:ext cx="10693440" cy="529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F0217D-78E6-4FCA-872B-826A3A19E9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93640" y="322200"/>
            <a:ext cx="10693440" cy="13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93640" y="1873080"/>
            <a:ext cx="10693440" cy="529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94A6CE-041F-420E-BDE0-08A814FEEE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93640" y="322200"/>
            <a:ext cx="10693440" cy="13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93640" y="1873080"/>
            <a:ext cx="5218200" cy="529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073200" y="1873080"/>
            <a:ext cx="5218200" cy="529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3D0121-EE8D-4197-B3AB-C8E36F53FC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93640" y="322200"/>
            <a:ext cx="10693440" cy="13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D33D87-1D6E-46E8-A569-A4C1FEC599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93640" y="322200"/>
            <a:ext cx="10693440" cy="620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8E7D3D-F994-47C6-A36E-A43FE36910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93640" y="322200"/>
            <a:ext cx="10693440" cy="13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93640" y="1873080"/>
            <a:ext cx="521820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073200" y="1873080"/>
            <a:ext cx="5218200" cy="529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93640" y="4641120"/>
            <a:ext cx="521820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5EFE1E-2C59-490B-876F-E98244F61E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93640" y="322200"/>
            <a:ext cx="10693440" cy="13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93640" y="1873080"/>
            <a:ext cx="5218200" cy="529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073200" y="1873080"/>
            <a:ext cx="521820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073200" y="4641120"/>
            <a:ext cx="521820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46390-8D89-4A55-9105-CFBA58D73D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93640" y="322200"/>
            <a:ext cx="10693440" cy="13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93640" y="1873080"/>
            <a:ext cx="521820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073200" y="1873080"/>
            <a:ext cx="521820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93640" y="4641120"/>
            <a:ext cx="10693440" cy="25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B39388-4DD8-419F-99EB-EEAEEA1C9D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93640" y="322200"/>
            <a:ext cx="10693440" cy="13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93640" y="1873080"/>
            <a:ext cx="10693440" cy="529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93640" y="7311960"/>
            <a:ext cx="2773440" cy="55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59000" y="7311960"/>
            <a:ext cx="3762360" cy="55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513640" y="7311960"/>
            <a:ext cx="2773440" cy="55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372205-4522-4504-9B0B-26E0EC1E52A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hyperlink" Target="http://archive.gramene.org/qtl/" TargetMode="External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3"/>
          <p:cNvGrpSpPr/>
          <p:nvPr/>
        </p:nvGrpSpPr>
        <p:grpSpPr>
          <a:xfrm>
            <a:off x="-480960" y="1195560"/>
            <a:ext cx="12441240" cy="5002560"/>
            <a:chOff x="-480960" y="1195560"/>
            <a:chExt cx="12441240" cy="5002560"/>
          </a:xfrm>
        </p:grpSpPr>
        <p:graphicFrame>
          <p:nvGraphicFramePr>
            <p:cNvPr id="42" name="图表 2"/>
            <p:cNvGraphicFramePr/>
            <p:nvPr/>
          </p:nvGraphicFramePr>
          <p:xfrm>
            <a:off x="-480960" y="1204560"/>
            <a:ext cx="6220440" cy="448560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图表 2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-480960" y="1204560"/>
                      <a:ext cx="6220440" cy="4485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4" name="图表 3"/>
            <p:cNvGraphicFramePr/>
            <p:nvPr/>
          </p:nvGraphicFramePr>
          <p:xfrm>
            <a:off x="4897800" y="1195560"/>
            <a:ext cx="7062480" cy="489312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45" name="图表 3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4897800" y="1195560"/>
                      <a:ext cx="7062480" cy="4893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6" name="矩形 1"/>
            <p:cNvSpPr/>
            <p:nvPr/>
          </p:nvSpPr>
          <p:spPr>
            <a:xfrm>
              <a:off x="1008000" y="5926320"/>
              <a:ext cx="190440" cy="206280"/>
            </a:xfrm>
            <a:prstGeom prst="rect">
              <a:avLst/>
            </a:prstGeom>
            <a:solidFill>
              <a:srgbClr val="1902c2"/>
            </a:solidFill>
            <a:ln w="25560">
              <a:solidFill>
                <a:srgbClr val="1902c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2"/>
            <p:cNvSpPr/>
            <p:nvPr/>
          </p:nvSpPr>
          <p:spPr>
            <a:xfrm>
              <a:off x="1539720" y="5811840"/>
              <a:ext cx="3349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Primary panicle branch numbe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矩形 8"/>
            <p:cNvSpPr/>
            <p:nvPr/>
          </p:nvSpPr>
          <p:spPr>
            <a:xfrm>
              <a:off x="5826240" y="5943600"/>
              <a:ext cx="191880" cy="206280"/>
            </a:xfrm>
            <a:prstGeom prst="rect">
              <a:avLst/>
            </a:prstGeom>
            <a:solidFill>
              <a:srgbClr val="ff0000"/>
            </a:solidFill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9"/>
            <p:cNvSpPr/>
            <p:nvPr/>
          </p:nvSpPr>
          <p:spPr>
            <a:xfrm>
              <a:off x="6369120" y="5829840"/>
              <a:ext cx="3652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econdary panicle branch numbe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" name="文本框 2"/>
          <p:cNvSpPr/>
          <p:nvPr/>
        </p:nvSpPr>
        <p:spPr>
          <a:xfrm>
            <a:off x="1292400" y="6757920"/>
            <a:ext cx="95248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.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ublished QTLs for panicle structure. The dataset was collected from </a:t>
            </a:r>
            <a:r>
              <a:rPr b="0" lang="en-US" sz="1800" spc="-1" strike="noStrike" u="sng">
                <a:solidFill>
                  <a:srgbClr val="009999"/>
                </a:solidFill>
                <a:uFillTx/>
                <a:latin typeface="Arial"/>
                <a:hlinkClick r:id="rId5"/>
              </a:rPr>
              <a:t>http://archive.gramene.org/qtl/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彭 友林</cp:lastModifiedBy>
  <dcterms:modified xsi:type="dcterms:W3CDTF">2014-06-16T05:54:31Z</dcterms:modified>
  <cp:revision>10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